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91" r:id="rId2"/>
    <p:sldId id="295" r:id="rId3"/>
    <p:sldId id="292" r:id="rId4"/>
    <p:sldId id="296" r:id="rId5"/>
  </p:sldIdLst>
  <p:sldSz cx="8280400" cy="9906000"/>
  <p:notesSz cx="6858000" cy="931386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Times New Roman" pitchFamily="18" charset="0"/>
        <a:ea typeface="宋体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>
          <p15:clr>
            <a:srgbClr val="A4A3A4"/>
          </p15:clr>
        </p15:guide>
        <p15:guide id="2" pos="2609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34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dministrator" initials="Zhao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945" autoAdjust="0"/>
    <p:restoredTop sz="95441" autoAdjust="0"/>
  </p:normalViewPr>
  <p:slideViewPr>
    <p:cSldViewPr>
      <p:cViewPr>
        <p:scale>
          <a:sx n="50" d="100"/>
          <a:sy n="50" d="100"/>
        </p:scale>
        <p:origin x="2526" y="18"/>
      </p:cViewPr>
      <p:guideLst>
        <p:guide orient="horz" pos="3121"/>
        <p:guide pos="2609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>
      <p:cViewPr varScale="1">
        <p:scale>
          <a:sx n="60" d="100"/>
          <a:sy n="60" d="100"/>
        </p:scale>
        <p:origin x="-2490" y="-72"/>
      </p:cViewPr>
      <p:guideLst>
        <p:guide orient="horz" pos="2934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7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8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149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848170"/>
            <a:ext cx="2971800" cy="4656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64467B2C-118A-4D9D-9C30-013199D7225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23300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6C77A53-A0C1-4C49-B0A8-BB3F9281637C}" type="datetimeFigureOut">
              <a:rPr lang="zh-CN" altLang="en-US"/>
              <a:pPr>
                <a:defRPr/>
              </a:pPr>
              <a:t>2019/2/1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70088" y="698500"/>
            <a:ext cx="29178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085"/>
            <a:ext cx="5486400" cy="4191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  <a:endParaRPr lang="zh-CN" altLang="en-US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4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80791077-DD96-4E24-A17C-32E363CD307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904307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1" y="3076582"/>
            <a:ext cx="7038341" cy="2124074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42063" y="5613414"/>
            <a:ext cx="5796279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7890E0-26D3-4C99-BF52-C04BCED4B1E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D07B48-1B73-4D38-B71C-0F51B95D0B0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99794" y="881063"/>
            <a:ext cx="1759585" cy="79248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1037" y="881063"/>
            <a:ext cx="5094746" cy="79248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701C78-E760-444D-9567-860DBC6A28C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E8E553C-39AF-4768-BEC6-0BECF83159A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3616" y="6365885"/>
            <a:ext cx="7038341" cy="196691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3616" y="4198952"/>
            <a:ext cx="7038341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DD3B55B-E2A5-4688-974F-EBA3D63933C6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1034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32208" y="2862263"/>
            <a:ext cx="3427166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EF6411-2E71-4D91-B365-27020620A7EB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3" y="396883"/>
            <a:ext cx="7452361" cy="1651001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4022" y="2217742"/>
            <a:ext cx="3659094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4022" y="3141663"/>
            <a:ext cx="3659094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07293" y="2217742"/>
            <a:ext cx="3659093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07293" y="3141663"/>
            <a:ext cx="3659093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05B950-5E11-4132-96EF-457615ADF32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0CCBB5-3E4C-4FED-87FE-A400D00D550F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7D2337-A71F-467C-96FA-EAFE0CEF188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020" y="393712"/>
            <a:ext cx="2723716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37407" y="393712"/>
            <a:ext cx="4628973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14020" y="2073276"/>
            <a:ext cx="2723716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5E4615-CDE6-46B9-A4A6-A279C4367D4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23496" y="6934209"/>
            <a:ext cx="4968240" cy="81914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623496" y="885824"/>
            <a:ext cx="496824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623496" y="7753352"/>
            <a:ext cx="496824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C8273-9742-49F6-A52D-BEA951596E0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21031" y="881067"/>
            <a:ext cx="7038341" cy="16510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21031" y="2862263"/>
            <a:ext cx="7038341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マスタ</a:t>
            </a:r>
            <a:r>
              <a:rPr lang="en-US" altLang="zh-CN" smtClean="0"/>
              <a:t> </a:t>
            </a:r>
            <a:r>
              <a:rPr lang="zh-CN" altLang="en-US" smtClean="0"/>
              <a:t>テキストの書式設定</a:t>
            </a:r>
            <a:endParaRPr lang="en-US" altLang="zh-CN" smtClean="0"/>
          </a:p>
          <a:p>
            <a:pPr lvl="1"/>
            <a:r>
              <a:rPr lang="zh-CN" altLang="en-US" smtClean="0"/>
              <a:t>第</a:t>
            </a:r>
            <a:r>
              <a:rPr lang="en-US" altLang="zh-CN" smtClean="0"/>
              <a:t> 2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2"/>
            <a:r>
              <a:rPr lang="zh-CN" altLang="en-US" smtClean="0"/>
              <a:t>第</a:t>
            </a:r>
            <a:r>
              <a:rPr lang="en-US" altLang="zh-CN" smtClean="0"/>
              <a:t> 3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3"/>
            <a:r>
              <a:rPr lang="zh-CN" altLang="en-US" smtClean="0"/>
              <a:t>第</a:t>
            </a:r>
            <a:r>
              <a:rPr lang="en-US" altLang="zh-CN" smtClean="0"/>
              <a:t> 4 </a:t>
            </a:r>
            <a:r>
              <a:rPr lang="zh-CN" altLang="en-US" smtClean="0"/>
              <a:t>レベル</a:t>
            </a:r>
            <a:endParaRPr lang="en-US" altLang="zh-CN" smtClean="0"/>
          </a:p>
          <a:p>
            <a:pPr lvl="4"/>
            <a:r>
              <a:rPr lang="zh-CN" altLang="en-US" smtClean="0"/>
              <a:t>第</a:t>
            </a:r>
            <a:r>
              <a:rPr lang="en-US" altLang="zh-CN" smtClean="0"/>
              <a:t> 5 </a:t>
            </a:r>
            <a:r>
              <a:rPr lang="zh-CN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21033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829138" y="9024939"/>
            <a:ext cx="2622127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934289" y="9024939"/>
            <a:ext cx="1725083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0" sz="1400">
                <a:latin typeface="Times New Roman" pitchFamily="18" charset="0"/>
                <a:ea typeface="宋体" pitchFamily="2" charset="-122"/>
              </a:defRPr>
            </a:lvl1pPr>
          </a:lstStyle>
          <a:p>
            <a:pPr>
              <a:defRPr/>
            </a:pPr>
            <a:fld id="{99CEB16C-BE5E-458B-AB94-E26D36ED8BD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4428232" y="9417496"/>
            <a:ext cx="38164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 smtClean="0"/>
              <a:t>Additional file 1: Figure S1</a:t>
            </a:r>
            <a:endParaRPr lang="zh-CN" altLang="en-US" b="1" dirty="0"/>
          </a:p>
        </p:txBody>
      </p:sp>
      <p:pic>
        <p:nvPicPr>
          <p:cNvPr id="14" name="图片 13" descr="S1.e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89792" y="1689185"/>
            <a:ext cx="4700815" cy="304779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428232" y="9417496"/>
            <a:ext cx="38164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 smtClean="0"/>
              <a:t>Additional file 1: </a:t>
            </a:r>
            <a:r>
              <a:rPr lang="en-US" altLang="zh-CN" b="1" dirty="0" smtClean="0"/>
              <a:t>Figure </a:t>
            </a:r>
            <a:r>
              <a:rPr lang="en-US" altLang="zh-CN" b="1" dirty="0" smtClean="0"/>
              <a:t>S2</a:t>
            </a:r>
            <a:endParaRPr lang="zh-CN" altLang="en-US" b="1" dirty="0"/>
          </a:p>
        </p:txBody>
      </p:sp>
      <p:pic>
        <p:nvPicPr>
          <p:cNvPr id="13" name="图片 12" descr="S2.e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043856" y="2072680"/>
            <a:ext cx="5745610" cy="238084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4428232" y="9417496"/>
            <a:ext cx="38164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 smtClean="0"/>
              <a:t>Additional file 1: </a:t>
            </a:r>
            <a:r>
              <a:rPr lang="en-US" altLang="zh-CN" b="1" dirty="0" smtClean="0"/>
              <a:t>Figure </a:t>
            </a:r>
            <a:r>
              <a:rPr lang="en-US" altLang="zh-CN" b="1" dirty="0" smtClean="0"/>
              <a:t>S3</a:t>
            </a:r>
            <a:endParaRPr lang="zh-CN" altLang="en-US" b="1" dirty="0"/>
          </a:p>
        </p:txBody>
      </p:sp>
      <p:pic>
        <p:nvPicPr>
          <p:cNvPr id="15" name="图片 14" descr="S3.em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79960" y="1712640"/>
            <a:ext cx="3864371" cy="2980639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428232" y="9417496"/>
            <a:ext cx="38164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 smtClean="0"/>
              <a:t>Additional file 1: </a:t>
            </a:r>
            <a:r>
              <a:rPr lang="en-US" altLang="zh-CN" b="1" dirty="0" smtClean="0"/>
              <a:t>Table </a:t>
            </a:r>
            <a:r>
              <a:rPr lang="en-US" altLang="zh-CN" b="1" dirty="0" smtClean="0"/>
              <a:t>S1</a:t>
            </a:r>
            <a:endParaRPr lang="zh-CN" altLang="en-US" b="1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/>
        </p:nvGraphicFramePr>
        <p:xfrm>
          <a:off x="1619920" y="2055520"/>
          <a:ext cx="4932548" cy="1097280"/>
        </p:xfrm>
        <a:graphic>
          <a:graphicData uri="http://schemas.openxmlformats.org/drawingml/2006/table">
            <a:tbl>
              <a:tblPr/>
              <a:tblGrid>
                <a:gridCol w="1476164"/>
                <a:gridCol w="900100"/>
                <a:gridCol w="2556284"/>
              </a:tblGrid>
              <a:tr h="118715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800" b="1" kern="100" dirty="0" smtClean="0">
                          <a:latin typeface="Times New Roman"/>
                          <a:ea typeface="Times New Roman"/>
                          <a:cs typeface="Times New Roman"/>
                        </a:rPr>
                        <a:t>Reaction</a:t>
                      </a:r>
                      <a:endParaRPr lang="zh-CN" sz="800" b="1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kern="100" dirty="0" smtClean="0">
                          <a:latin typeface="Times New Roman"/>
                          <a:ea typeface="Times New Roman"/>
                          <a:cs typeface="Times New Roman"/>
                        </a:rPr>
                        <a:t>Target</a:t>
                      </a:r>
                      <a:endParaRPr lang="zh-CN" sz="800" b="1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b="1" u="none" kern="100" dirty="0" smtClean="0">
                          <a:latin typeface="Times New Roman"/>
                          <a:ea typeface="Times New Roman"/>
                          <a:cs typeface="Times New Roman"/>
                        </a:rPr>
                        <a:t>Sequence</a:t>
                      </a:r>
                      <a:endParaRPr lang="zh-CN" sz="800" b="1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31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800" u="none" kern="100" baseline="0" dirty="0" smtClean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quantitative PCR</a:t>
                      </a:r>
                      <a:endParaRPr lang="zh-CN" altLang="zh-CN" sz="800" u="none" kern="100" baseline="0" dirty="0" smtClean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i="1" u="none" kern="100" dirty="0" smtClean="0">
                          <a:latin typeface="Times New Roman"/>
                          <a:ea typeface="宋体"/>
                          <a:cs typeface="Times New Roman"/>
                        </a:rPr>
                        <a:t>HBZ</a:t>
                      </a:r>
                      <a:endParaRPr lang="zh-CN" sz="800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u="none" kern="100" dirty="0">
                          <a:latin typeface="+mn-lt"/>
                          <a:ea typeface="Times New Roman"/>
                          <a:cs typeface="Times New Roman"/>
                        </a:rPr>
                        <a:t>F</a:t>
                      </a:r>
                      <a:r>
                        <a:rPr lang="en-US" sz="800" u="none" kern="100" dirty="0" smtClean="0">
                          <a:latin typeface="+mn-lt"/>
                          <a:ea typeface="Times New Roman"/>
                          <a:cs typeface="Times New Roman"/>
                        </a:rPr>
                        <a:t>: ATGGCGGCCTCAGG</a:t>
                      </a:r>
                      <a:endParaRPr lang="zh-CN" sz="800" u="none" kern="100" dirty="0">
                        <a:latin typeface="+mn-lt"/>
                        <a:ea typeface="Times New Roman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u="none" kern="100" dirty="0">
                          <a:latin typeface="+mn-lt"/>
                          <a:ea typeface="Times New Roman"/>
                          <a:cs typeface="Times New Roman"/>
                        </a:rPr>
                        <a:t>R</a:t>
                      </a:r>
                      <a:r>
                        <a:rPr lang="en-US" sz="800" u="none" kern="100" dirty="0" smtClean="0">
                          <a:latin typeface="+mn-lt"/>
                          <a:ea typeface="Times New Roman"/>
                          <a:cs typeface="Times New Roman"/>
                        </a:rPr>
                        <a:t>: GCTTTCTCCCCTGGAGGGCC</a:t>
                      </a:r>
                      <a:endParaRPr lang="zh-CN" sz="800" u="none" kern="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31"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800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i="1" u="none" kern="100" dirty="0">
                          <a:latin typeface="Times New Roman"/>
                          <a:ea typeface="Times New Roman"/>
                          <a:cs typeface="Times New Roman"/>
                        </a:rPr>
                        <a:t>18S</a:t>
                      </a:r>
                      <a:endParaRPr lang="zh-CN" sz="800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800" u="none" kern="100" dirty="0">
                          <a:latin typeface="+mn-lt"/>
                          <a:ea typeface="Times New Roman"/>
                          <a:cs typeface="Times New Roman"/>
                        </a:rPr>
                        <a:t>F: AACCCGTTGAACCCCATT</a:t>
                      </a:r>
                      <a:endParaRPr lang="zh-CN" sz="800" u="none" kern="100" dirty="0">
                        <a:latin typeface="+mn-lt"/>
                        <a:ea typeface="Times New Roman"/>
                        <a:cs typeface="Times New Roman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800" u="none" kern="100" dirty="0">
                          <a:latin typeface="+mn-lt"/>
                          <a:ea typeface="Times New Roman"/>
                          <a:cs typeface="Times New Roman"/>
                        </a:rPr>
                        <a:t>R: CCATCCAATCGGTAGTAGCG</a:t>
                      </a:r>
                      <a:endParaRPr lang="zh-CN" sz="800" u="none" kern="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31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Times New Roman" pitchFamily="18" charset="0"/>
                          <a:cs typeface="Times New Roman" pitchFamily="18" charset="0"/>
                        </a:rPr>
                        <a:t>chromatin </a:t>
                      </a:r>
                      <a:r>
                        <a:rPr kumimoji="0" lang="en-US" altLang="zh-CN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Times New Roman" pitchFamily="18" charset="0"/>
                          <a:cs typeface="Times New Roman" pitchFamily="18" charset="0"/>
                        </a:rPr>
                        <a:t>immunoprecipitation</a:t>
                      </a:r>
                      <a:endParaRPr lang="zh-CN" sz="800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u="none" kern="100" dirty="0" smtClean="0">
                          <a:latin typeface="Times New Roman"/>
                          <a:ea typeface="Times New Roman"/>
                          <a:cs typeface="Times New Roman"/>
                        </a:rPr>
                        <a:t>WT-Luc</a:t>
                      </a:r>
                      <a:endParaRPr lang="zh-CN" sz="800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u="none" kern="100" dirty="0" smtClean="0">
                          <a:solidFill>
                            <a:schemeClr val="tx1"/>
                          </a:solidFill>
                          <a:latin typeface="+mn-lt"/>
                          <a:ea typeface="Times New Roman"/>
                          <a:cs typeface="Times New Roman"/>
                        </a:rPr>
                        <a:t>F: CCACAGGCGGGAGGCGGCAGAA</a:t>
                      </a:r>
                      <a:endParaRPr lang="zh-CN" sz="800" u="none" kern="100" dirty="0" smtClean="0">
                        <a:solidFill>
                          <a:schemeClr val="tx1"/>
                        </a:solidFill>
                        <a:latin typeface="+mn-lt"/>
                        <a:ea typeface="Times New Roman"/>
                        <a:cs typeface="Times New Roman"/>
                      </a:endParaRPr>
                    </a:p>
                    <a:p>
                      <a:pPr marL="0" algn="l" defTabSz="914400" rtl="0" eaLnBrk="1" latinLnBrk="0" hangingPunct="1">
                        <a:spcAft>
                          <a:spcPts val="0"/>
                        </a:spcAft>
                      </a:pPr>
                      <a:r>
                        <a:rPr lang="en-US" sz="800" u="none" kern="100" dirty="0" smtClean="0">
                          <a:solidFill>
                            <a:schemeClr val="tx1"/>
                          </a:solidFill>
                          <a:latin typeface="+mn-lt"/>
                          <a:ea typeface="Times New Roman"/>
                          <a:cs typeface="Times New Roman"/>
                        </a:rPr>
                        <a:t>R: TCATAAGCTCAGACCTCCGGGAAG</a:t>
                      </a:r>
                      <a:endParaRPr lang="zh-CN" sz="800" u="none" kern="100" dirty="0">
                        <a:solidFill>
                          <a:schemeClr val="tx1"/>
                        </a:solidFill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7431"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800" u="none" kern="100" dirty="0"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44518" marR="44518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800" u="none" kern="100" dirty="0" smtClean="0">
                          <a:solidFill>
                            <a:schemeClr val="tx1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’LTR-Luc</a:t>
                      </a:r>
                      <a:endParaRPr lang="zh-CN" sz="800" u="none" kern="100" dirty="0">
                        <a:solidFill>
                          <a:schemeClr val="tx1"/>
                        </a:solidFill>
                        <a:latin typeface="Times New Roman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u="none" kern="100" dirty="0">
                          <a:latin typeface="+mn-lt"/>
                          <a:ea typeface="Times New Roman"/>
                          <a:cs typeface="Times New Roman"/>
                        </a:rPr>
                        <a:t>F</a:t>
                      </a:r>
                      <a:r>
                        <a:rPr lang="en-US" sz="800" u="none" kern="100" dirty="0" smtClean="0">
                          <a:latin typeface="+mn-lt"/>
                          <a:ea typeface="Times New Roman"/>
                          <a:cs typeface="Times New Roman"/>
                        </a:rPr>
                        <a:t>: AATGACCATGAGCCCCA</a:t>
                      </a:r>
                      <a:endParaRPr lang="zh-CN" sz="800" u="none" kern="100" dirty="0">
                        <a:latin typeface="+mn-lt"/>
                        <a:ea typeface="Times New Roman"/>
                        <a:cs typeface="Times New Roman"/>
                      </a:endParaRPr>
                    </a:p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800" u="none" kern="100" dirty="0">
                          <a:latin typeface="+mn-lt"/>
                          <a:ea typeface="Times New Roman"/>
                          <a:cs typeface="Times New Roman"/>
                        </a:rPr>
                        <a:t>R</a:t>
                      </a:r>
                      <a:r>
                        <a:rPr lang="en-US" sz="800" u="none" kern="100" dirty="0" smtClean="0">
                          <a:latin typeface="+mn-lt"/>
                          <a:ea typeface="Times New Roman"/>
                          <a:cs typeface="Times New Roman"/>
                        </a:rPr>
                        <a:t>: GTGAGGGGTTGTCGTCA</a:t>
                      </a:r>
                      <a:endParaRPr lang="zh-CN" sz="800" u="none" kern="100" dirty="0">
                        <a:latin typeface="+mn-lt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547912" y="1309584"/>
            <a:ext cx="5112568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Supplemental Table 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宋体" pitchFamily="2" charset="-122"/>
                <a:cs typeface="Times New Roman" pitchFamily="18" charset="0"/>
              </a:rPr>
              <a:t>1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List of primers for </a:t>
            </a:r>
            <a:r>
              <a:rPr kumimoji="0" lang="en-US" altLang="zh-CN" sz="1400" b="0" i="0" u="none" strike="noStrike" cap="none" normalizeH="0" baseline="0" dirty="0" smtClean="0" bmk="OLE_LINK7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quantitative PCR and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chromatin </a:t>
            </a:r>
            <a:r>
              <a:rPr kumimoji="0" lang="en-US" altLang="zh-CN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immunoprecipitatio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默认设计模板">
      <a:majorFont>
        <a:latin typeface="Times New Roman"/>
        <a:ea typeface="宋体"/>
        <a:cs typeface=""/>
      </a:majorFont>
      <a:minorFont>
        <a:latin typeface="Times New Roman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19050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  <a:ea typeface="宋体" pitchFamily="2" charset="-122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598</TotalTime>
  <Words>72</Words>
  <Application>Microsoft Office PowerPoint</Application>
  <PresentationFormat>Custom</PresentationFormat>
  <Paragraphs>2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宋体</vt:lpstr>
      <vt:lpstr>Calibri</vt:lpstr>
      <vt:lpstr>Times New Roman</vt:lpstr>
      <vt:lpstr>默认设计模板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drj</dc:creator>
  <cp:lastModifiedBy>Subramanian N.</cp:lastModifiedBy>
  <cp:revision>1462</cp:revision>
  <dcterms:created xsi:type="dcterms:W3CDTF">2009-04-22T19:24:48Z</dcterms:created>
  <dcterms:modified xsi:type="dcterms:W3CDTF">2019-02-11T11:09:17Z</dcterms:modified>
</cp:coreProperties>
</file>